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4" r:id="rId5"/>
    <p:sldId id="28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97FE30A-67D1-A2D9-A1CD-561C89638DE0}" v="8" dt="2025-05-15T13:53:57.63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ander Lanz (Cancer and Genomic Sciences)" userId="S::a.lanz@bham.ac.uk::e34d0c78-4e43-4e2c-b506-295386d2d1eb" providerId="AD" clId="Web-{C97FE30A-67D1-A2D9-A1CD-561C89638DE0}"/>
    <pc:docChg chg="addSld delSld">
      <pc:chgData name="Alexander Lanz (Cancer and Genomic Sciences)" userId="S::a.lanz@bham.ac.uk::e34d0c78-4e43-4e2c-b506-295386d2d1eb" providerId="AD" clId="Web-{C97FE30A-67D1-A2D9-A1CD-561C89638DE0}" dt="2025-05-15T13:53:57.633" v="7"/>
      <pc:docMkLst>
        <pc:docMk/>
      </pc:docMkLst>
      <pc:sldChg chg="del">
        <pc:chgData name="Alexander Lanz (Cancer and Genomic Sciences)" userId="S::a.lanz@bham.ac.uk::e34d0c78-4e43-4e2c-b506-295386d2d1eb" providerId="AD" clId="Web-{C97FE30A-67D1-A2D9-A1CD-561C89638DE0}" dt="2025-05-15T13:53:57.633" v="7"/>
        <pc:sldMkLst>
          <pc:docMk/>
          <pc:sldMk cId="2049827513" sldId="257"/>
        </pc:sldMkLst>
      </pc:sldChg>
      <pc:sldChg chg="del">
        <pc:chgData name="Alexander Lanz (Cancer and Genomic Sciences)" userId="S::a.lanz@bham.ac.uk::e34d0c78-4e43-4e2c-b506-295386d2d1eb" providerId="AD" clId="Web-{C97FE30A-67D1-A2D9-A1CD-561C89638DE0}" dt="2025-05-15T13:53:47.023" v="2"/>
        <pc:sldMkLst>
          <pc:docMk/>
          <pc:sldMk cId="1700713182" sldId="258"/>
        </pc:sldMkLst>
      </pc:sldChg>
      <pc:sldChg chg="del">
        <pc:chgData name="Alexander Lanz (Cancer and Genomic Sciences)" userId="S::a.lanz@bham.ac.uk::e34d0c78-4e43-4e2c-b506-295386d2d1eb" providerId="AD" clId="Web-{C97FE30A-67D1-A2D9-A1CD-561C89638DE0}" dt="2025-05-15T13:53:47.851" v="3"/>
        <pc:sldMkLst>
          <pc:docMk/>
          <pc:sldMk cId="377998953" sldId="259"/>
        </pc:sldMkLst>
      </pc:sldChg>
      <pc:sldChg chg="del">
        <pc:chgData name="Alexander Lanz (Cancer and Genomic Sciences)" userId="S::a.lanz@bham.ac.uk::e34d0c78-4e43-4e2c-b506-295386d2d1eb" providerId="AD" clId="Web-{C97FE30A-67D1-A2D9-A1CD-561C89638DE0}" dt="2025-05-15T13:53:48.226" v="4"/>
        <pc:sldMkLst>
          <pc:docMk/>
          <pc:sldMk cId="2050985532" sldId="261"/>
        </pc:sldMkLst>
      </pc:sldChg>
      <pc:sldChg chg="del">
        <pc:chgData name="Alexander Lanz (Cancer and Genomic Sciences)" userId="S::a.lanz@bham.ac.uk::e34d0c78-4e43-4e2c-b506-295386d2d1eb" providerId="AD" clId="Web-{C97FE30A-67D1-A2D9-A1CD-561C89638DE0}" dt="2025-05-15T13:53:50.023" v="5"/>
        <pc:sldMkLst>
          <pc:docMk/>
          <pc:sldMk cId="3118464150" sldId="262"/>
        </pc:sldMkLst>
      </pc:sldChg>
      <pc:sldChg chg="del">
        <pc:chgData name="Alexander Lanz (Cancer and Genomic Sciences)" userId="S::a.lanz@bham.ac.uk::e34d0c78-4e43-4e2c-b506-295386d2d1eb" providerId="AD" clId="Web-{C97FE30A-67D1-A2D9-A1CD-561C89638DE0}" dt="2025-05-15T13:53:50.883" v="6"/>
        <pc:sldMkLst>
          <pc:docMk/>
          <pc:sldMk cId="1427493671" sldId="263"/>
        </pc:sldMkLst>
      </pc:sldChg>
      <pc:sldChg chg="add">
        <pc:chgData name="Alexander Lanz (Cancer and Genomic Sciences)" userId="S::a.lanz@bham.ac.uk::e34d0c78-4e43-4e2c-b506-295386d2d1eb" providerId="AD" clId="Web-{C97FE30A-67D1-A2D9-A1CD-561C89638DE0}" dt="2025-05-15T13:53:45.351" v="0"/>
        <pc:sldMkLst>
          <pc:docMk/>
          <pc:sldMk cId="3413900162" sldId="264"/>
        </pc:sldMkLst>
      </pc:sldChg>
      <pc:sldChg chg="add">
        <pc:chgData name="Alexander Lanz (Cancer and Genomic Sciences)" userId="S::a.lanz@bham.ac.uk::e34d0c78-4e43-4e2c-b506-295386d2d1eb" providerId="AD" clId="Web-{C97FE30A-67D1-A2D9-A1CD-561C89638DE0}" dt="2025-05-15T13:53:45.383" v="1"/>
        <pc:sldMkLst>
          <pc:docMk/>
          <pc:sldMk cId="491764421" sldId="28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7186B-9E24-E88B-6F53-7B37765E0B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FE9DF52-13F8-AB39-B4B7-2DAEFBD101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D7A33B-9F8F-FC20-A19F-02A2025DA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8E6F5F-28EA-6BBC-847C-A48D492A6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FE0ED0-5936-F9C7-D0B8-B56269524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222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8D31EC-0B2F-0632-EB78-2820B3D8E7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9CB96C-CBA0-C1ED-16B5-FB839D526F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A5C114-C4A5-7FB6-2B05-B05880629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64D450-E0F2-5F47-F211-B2F681D8B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C5EB73-21DA-96A2-A764-9185CDEAC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1031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D52B601-411A-8E2D-45C1-57B4B8BB51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05A783-E3BC-7540-328D-B02D9140F0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0940B7-BE72-8657-BC98-319092E8A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932413-BAEA-EE82-BC19-96A50C448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ABF88D-6CB5-F616-2B93-FE6A750D6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6107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8CE0BD-2498-93FD-B7AC-5C95597071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027B9F-DA52-40FF-09CB-2E496E06E9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81CB96-3618-4861-87A2-CED59D449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E8714A-773F-E92B-242A-4F67C5F51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2B338-D8C9-38D1-4377-E2FB0C4AC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429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D87DA3-7B89-7BB8-16AA-512DC04C5A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1C02DF-AA84-AE0F-DB47-D5792161D9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48616F-EFF4-8EB6-0F6A-55027306E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A1F961-F9BA-F6C4-B392-79A68EE8D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EBB163-1FF8-FDF4-167B-53DBCC89F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9603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377C4C-C584-95A2-282F-10621B3EB5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588C25-7096-7DF6-A387-1A633AB61C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C9816E-2B86-B3AC-4D37-14DFA5D5DD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AA1FD8-83D4-D879-5C42-6617FCE1E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9D9B7B-E417-976C-6F5C-719A8F9A5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975325-5D24-3899-C1DB-954F7923F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9634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B92D13-4E97-D863-80E5-0B71840240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AF5D8A-7916-A418-6759-F27A79A0FD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D82EBD-EC65-9354-0757-406298AD8E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B9D647-2AA2-AA76-871F-A611D70DD6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9609D6-AB68-0B6B-A2BE-A73772E078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2B565E-987B-2995-311F-8401C6AD0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F105AB-1070-7549-C8CE-C08F9FDBE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E7A0B1A-C053-0829-FAF1-5D33DAD49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2868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030715-445E-BC9F-2166-2E4EB2DA6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43B270E-F135-C848-88F5-9C5C38976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968C7A6-CDDE-2825-1676-17E8B030BD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90D162-8143-D674-173F-19C1E1C67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0732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E1BBB1-B1AB-A757-096A-554ECDC82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D3C51A7-E6F3-4755-78AA-A1FF5BB35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064F05-92DD-E4CE-672A-C607A33B5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3114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F9AC81-8E48-28E4-385E-2DF35F411D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05D76D-CD27-5BC1-08F3-D97C9620C0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AA3193-1F5A-523C-9EF4-359EB236AA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20DB9F-372A-E1A3-3C7B-39A5EF94E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84F328-8ACB-7DFA-6C59-0059E8EC7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D997D4-93A0-BC97-B125-E4A5FA59F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795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079587-41B6-EE8C-231F-498656F427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DD48347-2FB5-80E2-A909-7921C4B253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4AC9EF-411E-E799-D67E-65BF66CC1B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C648BC-3D18-1C16-8E32-11A88E5C0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C1EFAE-9479-FEA4-F63E-144E621E2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334398-D531-5F20-7679-B5919B986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439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69EDA9-3769-D7FA-1B6A-3B200E6A1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489290-A3FA-27CC-B703-EA66495BDD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11F5BB-376F-DFDE-5A14-33FE869B74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33E12D-86F1-4BE7-93C8-BA16EBB5C9FB}" type="datetimeFigureOut">
              <a:rPr lang="en-GB" smtClean="0"/>
              <a:t>15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E4B178-45E3-400E-8663-FA17D5BB33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E103E6-324C-8646-6FD6-1DB08BBC5A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0954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13" Type="http://schemas.openxmlformats.org/officeDocument/2006/relationships/image" Target="../media/image13.jpeg"/><Relationship Id="rId18" Type="http://schemas.openxmlformats.org/officeDocument/2006/relationships/image" Target="../media/image1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12" Type="http://schemas.openxmlformats.org/officeDocument/2006/relationships/image" Target="../media/image12.jpeg"/><Relationship Id="rId17" Type="http://schemas.openxmlformats.org/officeDocument/2006/relationships/image" Target="../media/image17.jpeg"/><Relationship Id="rId2" Type="http://schemas.openxmlformats.org/officeDocument/2006/relationships/image" Target="../media/image2.jpeg"/><Relationship Id="rId16" Type="http://schemas.openxmlformats.org/officeDocument/2006/relationships/image" Target="../media/image16.jpeg"/><Relationship Id="rId20" Type="http://schemas.openxmlformats.org/officeDocument/2006/relationships/image" Target="../media/image2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5" Type="http://schemas.openxmlformats.org/officeDocument/2006/relationships/image" Target="../media/image5.jpeg"/><Relationship Id="rId15" Type="http://schemas.openxmlformats.org/officeDocument/2006/relationships/image" Target="../media/image15.jpeg"/><Relationship Id="rId10" Type="http://schemas.openxmlformats.org/officeDocument/2006/relationships/image" Target="../media/image10.jpeg"/><Relationship Id="rId19" Type="http://schemas.openxmlformats.org/officeDocument/2006/relationships/image" Target="../media/image19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Relationship Id="rId14" Type="http://schemas.openxmlformats.org/officeDocument/2006/relationships/image" Target="../media/image1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AE99777-499D-07D0-32B9-8C9C1DABF5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438F5F3-E52F-737D-B60A-CE5378B848FA}"/>
              </a:ext>
            </a:extLst>
          </p:cNvPr>
          <p:cNvSpPr txBox="1"/>
          <p:nvPr/>
        </p:nvSpPr>
        <p:spPr>
          <a:xfrm>
            <a:off x="0" y="0"/>
            <a:ext cx="8518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2c – SAE1:2 WT/C173G/K164Q/K164R loading assay with SUMO1/SUMO2.</a:t>
            </a:r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F05A6FF0-09D2-17B6-7DD0-02A00B7D16B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564" b="53163"/>
          <a:stretch/>
        </p:blipFill>
        <p:spPr bwMode="auto">
          <a:xfrm>
            <a:off x="114300" y="369332"/>
            <a:ext cx="2957513" cy="32120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13900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51" t="38335" r="29970" b="21025"/>
          <a:stretch/>
        </p:blipFill>
        <p:spPr>
          <a:xfrm>
            <a:off x="2053266" y="736664"/>
            <a:ext cx="2130725" cy="1506203"/>
          </a:xfrm>
        </p:spPr>
      </p:pic>
      <p:sp>
        <p:nvSpPr>
          <p:cNvPr id="5" name="TextBox 4"/>
          <p:cNvSpPr txBox="1"/>
          <p:nvPr/>
        </p:nvSpPr>
        <p:spPr>
          <a:xfrm>
            <a:off x="10691064" y="-51009"/>
            <a:ext cx="5559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est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1381" y="-31192"/>
            <a:ext cx="7621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MO1 loading lanes: 1. WT-ATP, 2. WT+ATP, 3. CG+ATP, 4. KQ+ATP, 5. KR+ATP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20" t="12269" r="47287" b="63388"/>
          <a:stretch/>
        </p:blipFill>
        <p:spPr>
          <a:xfrm>
            <a:off x="2053266" y="2299837"/>
            <a:ext cx="2229389" cy="147206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rot="16200000">
            <a:off x="-273679" y="1071724"/>
            <a:ext cx="1039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lexa488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-109915" y="2795749"/>
            <a:ext cx="711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ypro</a:t>
            </a:r>
            <a:endParaRPr lang="en-GB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92" t="62041" r="44515" b="3065"/>
          <a:stretch/>
        </p:blipFill>
        <p:spPr>
          <a:xfrm>
            <a:off x="2412498" y="5261392"/>
            <a:ext cx="1510923" cy="143017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42" t="4134" r="57881" b="64051"/>
          <a:stretch/>
        </p:blipFill>
        <p:spPr>
          <a:xfrm>
            <a:off x="781049" y="774772"/>
            <a:ext cx="1104901" cy="14511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09" t="7041" r="54392" b="60336"/>
          <a:stretch/>
        </p:blipFill>
        <p:spPr>
          <a:xfrm>
            <a:off x="781049" y="2374353"/>
            <a:ext cx="1113887" cy="1397547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76" t="56783" r="54650" b="2035"/>
          <a:stretch/>
        </p:blipFill>
        <p:spPr>
          <a:xfrm>
            <a:off x="874038" y="5320263"/>
            <a:ext cx="859512" cy="1312428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92" t="48708" r="57364" b="21092"/>
          <a:stretch/>
        </p:blipFill>
        <p:spPr>
          <a:xfrm>
            <a:off x="877159" y="3962808"/>
            <a:ext cx="885827" cy="1166546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13" t="18701" r="45466" b="37678"/>
          <a:stretch/>
        </p:blipFill>
        <p:spPr>
          <a:xfrm>
            <a:off x="2412498" y="3962808"/>
            <a:ext cx="1413296" cy="1226241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77" t="16658" r="22667" b="13897"/>
          <a:stretch/>
        </p:blipFill>
        <p:spPr>
          <a:xfrm>
            <a:off x="9973061" y="760853"/>
            <a:ext cx="1749039" cy="1414583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2188414" y="357815"/>
            <a:ext cx="566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=2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990078" y="405440"/>
            <a:ext cx="566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=1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273679" y="4395949"/>
            <a:ext cx="1039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lexa647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-109915" y="5824699"/>
            <a:ext cx="711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ypro</a:t>
            </a:r>
            <a:endParaRPr lang="en-GB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28665" y="2225874"/>
            <a:ext cx="1437830" cy="1150089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11738360" y="1591450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647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5357" y="736672"/>
            <a:ext cx="1878511" cy="1503426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7112186" y="328924"/>
            <a:ext cx="566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=4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104225" y="376549"/>
            <a:ext cx="566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=3</a:t>
            </a: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8131" y="698256"/>
            <a:ext cx="1924369" cy="1539778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5466456" y="698256"/>
            <a:ext cx="37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A</a:t>
            </a:r>
            <a:r>
              <a:rPr lang="en-GB" dirty="0"/>
              <a:t> 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588920" y="699636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D</a:t>
            </a:r>
            <a:r>
              <a:rPr lang="en-GB" dirty="0"/>
              <a:t>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790152" y="888685"/>
            <a:ext cx="37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A</a:t>
            </a:r>
            <a:r>
              <a:rPr lang="en-GB" dirty="0"/>
              <a:t> 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650676" y="890065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D</a:t>
            </a:r>
            <a:r>
              <a:rPr lang="en-GB" dirty="0"/>
              <a:t>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138" b="54628"/>
          <a:stretch/>
        </p:blipFill>
        <p:spPr>
          <a:xfrm>
            <a:off x="4462336" y="2374354"/>
            <a:ext cx="1881532" cy="1291948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6" t="50613" r="44282" b="4015"/>
          <a:stretch/>
        </p:blipFill>
        <p:spPr>
          <a:xfrm>
            <a:off x="6639143" y="2374353"/>
            <a:ext cx="1912021" cy="1312883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720" t="4016" b="58812"/>
          <a:stretch/>
        </p:blipFill>
        <p:spPr>
          <a:xfrm>
            <a:off x="4462336" y="5320263"/>
            <a:ext cx="2176807" cy="139875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70" t="53629" r="-1350" b="9199"/>
          <a:stretch/>
        </p:blipFill>
        <p:spPr>
          <a:xfrm>
            <a:off x="6767576" y="5320263"/>
            <a:ext cx="2176807" cy="1398750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9823801" y="561215"/>
            <a:ext cx="1162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WT-CG-pS185-KQ-KR</a:t>
            </a:r>
            <a:endParaRPr lang="en-GB" dirty="0"/>
          </a:p>
        </p:txBody>
      </p:sp>
      <p:sp>
        <p:nvSpPr>
          <p:cNvPr id="35" name="TextBox 34"/>
          <p:cNvSpPr txBox="1"/>
          <p:nvPr/>
        </p:nvSpPr>
        <p:spPr>
          <a:xfrm>
            <a:off x="10951750" y="559031"/>
            <a:ext cx="1162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WT-CG-pS185-KQ-KR</a:t>
            </a:r>
            <a:endParaRPr lang="en-GB" dirty="0"/>
          </a:p>
        </p:txBody>
      </p:sp>
      <p:sp>
        <p:nvSpPr>
          <p:cNvPr id="36" name="TextBox 35"/>
          <p:cNvSpPr txBox="1"/>
          <p:nvPr/>
        </p:nvSpPr>
        <p:spPr>
          <a:xfrm>
            <a:off x="9720265" y="128586"/>
            <a:ext cx="23532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5 seconds with SUMO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0103759" y="319404"/>
            <a:ext cx="777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On ice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0839400" y="313252"/>
            <a:ext cx="1308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t 30 deg. C</a:t>
            </a: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3549" y="3923433"/>
            <a:ext cx="1639227" cy="1311920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7576" y="3923433"/>
            <a:ext cx="1636195" cy="1309196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9617" y="3771900"/>
            <a:ext cx="2478194" cy="1982175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91366" y="5748438"/>
            <a:ext cx="2496445" cy="19971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1764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68EA6A78B6EFB4D9985178F3F279F4C" ma:contentTypeVersion="19" ma:contentTypeDescription="Create a new document." ma:contentTypeScope="" ma:versionID="29c48e0d9218662d081e5238f2da448e">
  <xsd:schema xmlns:xsd="http://www.w3.org/2001/XMLSchema" xmlns:xs="http://www.w3.org/2001/XMLSchema" xmlns:p="http://schemas.microsoft.com/office/2006/metadata/properties" xmlns:ns2="41a39341-79ea-44d6-85e4-75c150cb81b7" xmlns:ns3="b375cec7-7e7c-4052-8797-185a20106aa9" targetNamespace="http://schemas.microsoft.com/office/2006/metadata/properties" ma:root="true" ma:fieldsID="b887e77f8bef3478815c8c3177f18cc1" ns2:_="" ns3:_="">
    <xsd:import namespace="41a39341-79ea-44d6-85e4-75c150cb81b7"/>
    <xsd:import namespace="b375cec7-7e7c-4052-8797-185a20106a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Location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1a39341-79ea-44d6-85e4-75c150cb81b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ac7af76c-f141-45ca-ae1a-4959eb0cbd4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Location" ma:index="24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375cec7-7e7c-4052-8797-185a20106aa9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b036a36d-b287-438b-9595-27e3ad313660}" ma:internalName="TaxCatchAll" ma:showField="CatchAllData" ma:web="b375cec7-7e7c-4052-8797-185a20106a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b375cec7-7e7c-4052-8797-185a20106aa9" xsi:nil="true"/>
    <lcf76f155ced4ddcb4097134ff3c332f xmlns="41a39341-79ea-44d6-85e4-75c150cb81b7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F9B93AA-1F77-4B3D-96DC-CEBF25C41F3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1a39341-79ea-44d6-85e4-75c150cb81b7"/>
    <ds:schemaRef ds:uri="b375cec7-7e7c-4052-8797-185a20106aa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780AC18-BC22-4EE4-B502-DC535FCC8780}">
  <ds:schemaRefs>
    <ds:schemaRef ds:uri="http://schemas.microsoft.com/office/2006/metadata/properties"/>
    <ds:schemaRef ds:uri="http://schemas.microsoft.com/office/infopath/2007/PartnerControls"/>
    <ds:schemaRef ds:uri="b375cec7-7e7c-4052-8797-185a20106aa9"/>
    <ds:schemaRef ds:uri="41a39341-79ea-44d6-85e4-75c150cb81b7"/>
  </ds:schemaRefs>
</ds:datastoreItem>
</file>

<file path=customXml/itemProps3.xml><?xml version="1.0" encoding="utf-8"?>
<ds:datastoreItem xmlns:ds="http://schemas.openxmlformats.org/officeDocument/2006/customXml" ds:itemID="{19645B47-6E1C-448E-A189-AB313F7AEF97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07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niversity of Birm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exander Lanz (Cancer and Genomic Sciences)</dc:creator>
  <cp:lastModifiedBy>Alexander Lanz (Cancer and Genomic Sciences)</cp:lastModifiedBy>
  <cp:revision>4</cp:revision>
  <dcterms:created xsi:type="dcterms:W3CDTF">2025-03-03T09:16:53Z</dcterms:created>
  <dcterms:modified xsi:type="dcterms:W3CDTF">2025-05-15T13:54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68EA6A78B6EFB4D9985178F3F279F4C</vt:lpwstr>
  </property>
  <property fmtid="{D5CDD505-2E9C-101B-9397-08002B2CF9AE}" pid="3" name="MediaServiceImageTags">
    <vt:lpwstr/>
  </property>
</Properties>
</file>